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8" d="100"/>
          <a:sy n="98" d="100"/>
        </p:scale>
        <p:origin x="110" y="1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ADCA3EE-A27A-4079-ADBE-1A7ECAE136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DCD5F37F-C3E3-4A27-A328-20F55EB297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FB93AA8-B65A-49A3-9298-1049D9029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40854-7C7F-4740-847A-49128B4E8B9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58F0AE7-DE9A-4785-89E4-83967542A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E89C3B9-354B-4AAF-AD7C-ED425617A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18BC7-D876-44CA-877C-5D7939DB6A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0526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BFAF2B3-9E25-4B1E-BD7F-C4D28F56E4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724630A-0C59-460E-95DD-2E3BB1AF10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2C9461D-1A19-4370-B81F-13A469C42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40854-7C7F-4740-847A-49128B4E8B9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728F11A-36C0-4F73-8496-8169EFACD9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4703CAC-7796-47F0-8ECB-5550444728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18BC7-D876-44CA-877C-5D7939DB6A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8562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F2BCE223-0CEE-44A2-B983-521CC3A89BE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27C170D-C673-4DD9-BB09-EC8F7381ED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A626D34-B2CA-43EE-8651-A67A05EB8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40854-7C7F-4740-847A-49128B4E8B9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BA7FC68-3F60-4D95-86F2-55661AA47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E9600BB-97E9-4EB2-ACE9-B862F537B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18BC7-D876-44CA-877C-5D7939DB6A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12703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3E63CBE-79D7-4AF0-BE12-0F296B9655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2DF2D9D-E4A7-414C-86D3-BF3ED4EF6C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018AB4F-2574-4B1C-B8E0-522E401B4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40854-7C7F-4740-847A-49128B4E8B9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F48C85B-92B6-45B6-9159-FC917C54F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48ABD34-6DB1-4104-AD74-3EC448ED74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18BC7-D876-44CA-877C-5D7939DB6A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7036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BED3C1D-6A74-4F66-9C62-4D73E55A6D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43D710B-7C1D-4858-9E7B-6C5996514D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9B11275-0097-4156-AFAB-913E9D219B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40854-7C7F-4740-847A-49128B4E8B9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BA0CE71-6899-40E9-837D-75780A6342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168F7E4-ADA1-4345-8E43-DA026A6671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18BC7-D876-44CA-877C-5D7939DB6A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1679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7E26D0E-F844-4628-BDAB-2C2E131340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0E62C38-E0AD-4260-AEA4-14EB3B4817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968A7FC-849F-472B-8F14-4729043AB1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4533677-136D-4EA8-8450-5124D9287C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40854-7C7F-4740-847A-49128B4E8B9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5D0903C-8E52-4432-B470-810D62745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E5CBFDF-9BA4-4E74-9555-32A85E7673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18BC7-D876-44CA-877C-5D7939DB6A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793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228BE5C-7E04-4D92-9701-75DF57BA05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80CAC9F-5498-41DA-B84D-85647A3969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0CCE8D47-325E-4714-AAF4-3E501BD56D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DEB9088A-96D2-4CB6-9512-E10D8A7063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C634F2B7-F648-4B42-9FA8-69CEA2DDEF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66CDC0B5-C1D8-4A4F-9B8E-4A87170ADB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40854-7C7F-4740-847A-49128B4E8B9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A2A10F6C-DC3A-4ED6-8407-17E6D88EAF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B1A91D4C-9BEB-46C7-9540-9ED29F7A6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18BC7-D876-44CA-877C-5D7939DB6A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69997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5315605-B2B5-4F6F-ACCB-976D14DD77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8B18D843-7C3C-4F6E-8E31-14DDD61658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40854-7C7F-4740-847A-49128B4E8B9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5FD14D94-DCEB-40D1-96AC-9A716A67E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060DA3F3-81FD-43BB-BC3B-22407E33C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18BC7-D876-44CA-877C-5D7939DB6A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7299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AC37BFE1-DD02-4860-A18F-AF2D74F453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40854-7C7F-4740-847A-49128B4E8B9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702FC405-5919-4F62-82D8-D6AAC9475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E3920BA7-8FB4-422C-91F8-8F447C48B7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18BC7-D876-44CA-877C-5D7939DB6A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62001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4A008A2-D22D-4578-983B-69968FAABF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FB39D75-34D8-4D0C-86C7-7B5179F597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8102D8A-1AD8-4F06-94FB-DDF7ED278D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628BBC9-950A-4C48-9CA9-42ACCEAC7B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40854-7C7F-4740-847A-49128B4E8B9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01DF65C-D440-4892-AC3B-D39F5F969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9E1A7D6-4CD3-480B-8001-856491D67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18BC7-D876-44CA-877C-5D7939DB6A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89391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142AC8E-DB90-4E63-AAC0-0C00CB28D7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D1AFFDC6-0BC3-4760-875A-8E39E58CFC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61CDAFF-D558-4799-9695-803A79806B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6D906D1-FEF5-406B-95CF-74723ED53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040854-7C7F-4740-847A-49128B4E8B9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2DEBDCF-3F50-485B-B25F-F86544C2F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4B490A1-BB64-4019-AA7C-EBE11B026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18BC7-D876-44CA-877C-5D7939DB6A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2197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5424091-0FF9-41B0-B148-1F559DC442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058F72D-FC9A-459E-92BB-B37136DFCE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06EB18F-3F7D-449E-805F-80A23130DAA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040854-7C7F-4740-847A-49128B4E8B9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844E037-7092-4037-BFB2-08C977F499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9EBE0A9-47B1-4C20-AFFD-9CD386A68E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618BC7-D876-44CA-877C-5D7939DB6A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8975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20F48DAB-9BE6-48E4-A831-BD64787DEDEE}"/>
              </a:ext>
            </a:extLst>
          </p:cNvPr>
          <p:cNvSpPr txBox="1"/>
          <p:nvPr/>
        </p:nvSpPr>
        <p:spPr>
          <a:xfrm>
            <a:off x="7091927" y="310896"/>
            <a:ext cx="474041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/>
              <a:t>Table </a:t>
            </a:r>
            <a:r>
              <a:rPr lang="de-DE" sz="1100" b="1" smtClean="0"/>
              <a:t>4. </a:t>
            </a:r>
            <a:r>
              <a:rPr lang="de-DE" sz="1100" b="1" dirty="0" err="1"/>
              <a:t>Fiducial</a:t>
            </a:r>
            <a:r>
              <a:rPr lang="de-DE" sz="1100" b="1" dirty="0"/>
              <a:t> </a:t>
            </a:r>
            <a:r>
              <a:rPr lang="de-DE" sz="1100" b="1" dirty="0" err="1"/>
              <a:t>detection</a:t>
            </a:r>
            <a:r>
              <a:rPr lang="de-DE" sz="1100" b="1" dirty="0"/>
              <a:t> rate </a:t>
            </a:r>
            <a:r>
              <a:rPr lang="de-DE" sz="1100" b="1" dirty="0" err="1"/>
              <a:t>by</a:t>
            </a:r>
            <a:r>
              <a:rPr lang="de-DE" sz="1100" b="1" dirty="0"/>
              <a:t> BMI </a:t>
            </a:r>
            <a:r>
              <a:rPr lang="de-DE" sz="1100" b="1" dirty="0" err="1"/>
              <a:t>group</a:t>
            </a:r>
            <a:r>
              <a:rPr lang="de-DE" sz="1100" b="1" dirty="0"/>
              <a:t>. </a:t>
            </a:r>
            <a:r>
              <a:rPr lang="de-DE" sz="1100" dirty="0"/>
              <a:t>The BMI </a:t>
            </a:r>
            <a:r>
              <a:rPr lang="de-DE" sz="1100" dirty="0" err="1"/>
              <a:t>groups</a:t>
            </a:r>
            <a:r>
              <a:rPr lang="de-DE" sz="1100" dirty="0"/>
              <a:t> </a:t>
            </a:r>
            <a:r>
              <a:rPr lang="de-DE" sz="1100" dirty="0" err="1"/>
              <a:t>were</a:t>
            </a:r>
            <a:r>
              <a:rPr lang="de-DE" sz="1100" dirty="0"/>
              <a:t> </a:t>
            </a:r>
            <a:r>
              <a:rPr lang="de-DE" sz="1100" dirty="0" err="1"/>
              <a:t>devised</a:t>
            </a:r>
            <a:r>
              <a:rPr lang="de-DE" sz="1100" dirty="0"/>
              <a:t> </a:t>
            </a:r>
            <a:r>
              <a:rPr lang="de-DE" sz="1100" dirty="0" err="1"/>
              <a:t>according</a:t>
            </a:r>
            <a:r>
              <a:rPr lang="de-DE" sz="1100" dirty="0"/>
              <a:t> </a:t>
            </a:r>
            <a:r>
              <a:rPr lang="de-DE" sz="1100" dirty="0" err="1"/>
              <a:t>to</a:t>
            </a:r>
            <a:r>
              <a:rPr lang="de-DE" sz="1100" dirty="0"/>
              <a:t> the </a:t>
            </a:r>
            <a:r>
              <a:rPr lang="de-DE" sz="1100" dirty="0" err="1"/>
              <a:t>official</a:t>
            </a:r>
            <a:r>
              <a:rPr lang="de-DE" sz="1100" dirty="0"/>
              <a:t> BMI </a:t>
            </a:r>
            <a:r>
              <a:rPr lang="de-DE" sz="1100" dirty="0" err="1"/>
              <a:t>classification</a:t>
            </a:r>
            <a:r>
              <a:rPr lang="de-DE" sz="1100" dirty="0"/>
              <a:t>. 48 of 64 </a:t>
            </a:r>
            <a:r>
              <a:rPr lang="de-DE" sz="1100" dirty="0" err="1"/>
              <a:t>patients</a:t>
            </a:r>
            <a:r>
              <a:rPr lang="de-DE" sz="1100" dirty="0"/>
              <a:t> </a:t>
            </a:r>
            <a:r>
              <a:rPr lang="de-DE" sz="1100" dirty="0" err="1"/>
              <a:t>were</a:t>
            </a:r>
            <a:r>
              <a:rPr lang="de-DE" sz="1100" dirty="0"/>
              <a:t> </a:t>
            </a:r>
            <a:r>
              <a:rPr lang="de-DE" sz="1100" dirty="0" err="1"/>
              <a:t>analyzed</a:t>
            </a:r>
            <a:r>
              <a:rPr lang="de-DE" sz="1100" dirty="0"/>
              <a:t> due </a:t>
            </a:r>
            <a:r>
              <a:rPr lang="de-DE" sz="1100" dirty="0" err="1"/>
              <a:t>to</a:t>
            </a:r>
            <a:r>
              <a:rPr lang="de-DE" sz="1100" dirty="0"/>
              <a:t> </a:t>
            </a:r>
            <a:r>
              <a:rPr lang="de-DE" sz="1100" dirty="0" err="1"/>
              <a:t>missing</a:t>
            </a:r>
            <a:r>
              <a:rPr lang="de-DE" sz="1100" dirty="0"/>
              <a:t> </a:t>
            </a:r>
            <a:r>
              <a:rPr lang="de-DE" sz="1100" dirty="0" err="1"/>
              <a:t>height</a:t>
            </a:r>
            <a:r>
              <a:rPr lang="de-DE" sz="1100" dirty="0"/>
              <a:t> and/ </a:t>
            </a:r>
            <a:r>
              <a:rPr lang="de-DE" sz="1100" dirty="0" err="1"/>
              <a:t>or</a:t>
            </a:r>
            <a:r>
              <a:rPr lang="de-DE" sz="1100" dirty="0"/>
              <a:t> </a:t>
            </a:r>
            <a:r>
              <a:rPr lang="de-DE" sz="1100" dirty="0" err="1"/>
              <a:t>weight</a:t>
            </a:r>
            <a:r>
              <a:rPr lang="de-DE" sz="1100" dirty="0"/>
              <a:t> </a:t>
            </a:r>
            <a:r>
              <a:rPr lang="de-DE" sz="1100" dirty="0" err="1"/>
              <a:t>information</a:t>
            </a:r>
            <a:r>
              <a:rPr lang="de-DE" sz="1100" dirty="0"/>
              <a:t> in 16 </a:t>
            </a:r>
            <a:r>
              <a:rPr lang="de-DE" sz="1100" dirty="0" err="1"/>
              <a:t>patients</a:t>
            </a:r>
            <a:r>
              <a:rPr lang="de-DE" sz="1100" dirty="0"/>
              <a:t> (</a:t>
            </a:r>
            <a:r>
              <a:rPr lang="de-DE" sz="1100" dirty="0" err="1"/>
              <a:t>see</a:t>
            </a:r>
            <a:r>
              <a:rPr lang="de-DE" sz="1100" dirty="0"/>
              <a:t> </a:t>
            </a:r>
            <a:r>
              <a:rPr lang="de-DE" sz="1100" dirty="0" err="1"/>
              <a:t>patients`characteristics</a:t>
            </a:r>
            <a:r>
              <a:rPr lang="de-DE" sz="1100" dirty="0"/>
              <a:t>). There was </a:t>
            </a:r>
            <a:r>
              <a:rPr lang="de-DE" sz="1100" dirty="0" err="1"/>
              <a:t>no</a:t>
            </a:r>
            <a:r>
              <a:rPr lang="de-DE" sz="1100" dirty="0"/>
              <a:t> </a:t>
            </a:r>
            <a:r>
              <a:rPr lang="de-DE" sz="1100" dirty="0" err="1"/>
              <a:t>significant</a:t>
            </a:r>
            <a:r>
              <a:rPr lang="de-DE" sz="1100" dirty="0"/>
              <a:t> </a:t>
            </a:r>
            <a:r>
              <a:rPr lang="de-DE" sz="1100" dirty="0" err="1"/>
              <a:t>difference</a:t>
            </a:r>
            <a:r>
              <a:rPr lang="de-DE" sz="1100" dirty="0"/>
              <a:t> </a:t>
            </a:r>
            <a:r>
              <a:rPr lang="de-DE" sz="1100" dirty="0" err="1"/>
              <a:t>between</a:t>
            </a:r>
            <a:r>
              <a:rPr lang="de-DE" sz="1100" dirty="0"/>
              <a:t> the </a:t>
            </a:r>
            <a:r>
              <a:rPr lang="de-DE" sz="1100" dirty="0" err="1"/>
              <a:t>groups</a:t>
            </a:r>
            <a:r>
              <a:rPr lang="de-DE" sz="1100" dirty="0"/>
              <a:t> </a:t>
            </a:r>
            <a:r>
              <a:rPr lang="de-DE" sz="1100" dirty="0" err="1"/>
              <a:t>nor</a:t>
            </a:r>
            <a:r>
              <a:rPr lang="de-DE" sz="1100" dirty="0"/>
              <a:t> </a:t>
            </a:r>
            <a:r>
              <a:rPr lang="de-DE" sz="1100" dirty="0" err="1"/>
              <a:t>could</a:t>
            </a:r>
            <a:r>
              <a:rPr lang="de-DE" sz="1100" dirty="0"/>
              <a:t> a </a:t>
            </a:r>
            <a:r>
              <a:rPr lang="de-DE" sz="1100" dirty="0" err="1"/>
              <a:t>trend</a:t>
            </a:r>
            <a:r>
              <a:rPr lang="de-DE" sz="1100" dirty="0"/>
              <a:t> </a:t>
            </a:r>
            <a:r>
              <a:rPr lang="de-DE" sz="1100" dirty="0" err="1"/>
              <a:t>be</a:t>
            </a:r>
            <a:r>
              <a:rPr lang="de-DE" sz="1100" dirty="0"/>
              <a:t> </a:t>
            </a:r>
            <a:r>
              <a:rPr lang="de-DE" sz="1100" dirty="0" err="1"/>
              <a:t>detected</a:t>
            </a:r>
            <a:r>
              <a:rPr lang="de-DE" sz="1100" dirty="0"/>
              <a:t> over the course of the 5-fraction treatment.</a:t>
            </a:r>
          </a:p>
        </p:txBody>
      </p:sp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4B624459-E424-43B0-9721-EE74933F7B3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236193"/>
              </p:ext>
            </p:extLst>
          </p:nvPr>
        </p:nvGraphicFramePr>
        <p:xfrm>
          <a:off x="283464" y="310896"/>
          <a:ext cx="6601967" cy="6263660"/>
        </p:xfrm>
        <a:graphic>
          <a:graphicData uri="http://schemas.openxmlformats.org/drawingml/2006/table">
            <a:tbl>
              <a:tblPr firstRow="1" bandRow="1" bandCol="1"/>
              <a:tblGrid>
                <a:gridCol w="1251134">
                  <a:extLst>
                    <a:ext uri="{9D8B030D-6E8A-4147-A177-3AD203B41FA5}">
                      <a16:colId xmlns:a16="http://schemas.microsoft.com/office/drawing/2014/main" val="2666837447"/>
                    </a:ext>
                  </a:extLst>
                </a:gridCol>
                <a:gridCol w="1251134">
                  <a:extLst>
                    <a:ext uri="{9D8B030D-6E8A-4147-A177-3AD203B41FA5}">
                      <a16:colId xmlns:a16="http://schemas.microsoft.com/office/drawing/2014/main" val="2954012059"/>
                    </a:ext>
                  </a:extLst>
                </a:gridCol>
                <a:gridCol w="1251134">
                  <a:extLst>
                    <a:ext uri="{9D8B030D-6E8A-4147-A177-3AD203B41FA5}">
                      <a16:colId xmlns:a16="http://schemas.microsoft.com/office/drawing/2014/main" val="1972594169"/>
                    </a:ext>
                  </a:extLst>
                </a:gridCol>
                <a:gridCol w="1251134">
                  <a:extLst>
                    <a:ext uri="{9D8B030D-6E8A-4147-A177-3AD203B41FA5}">
                      <a16:colId xmlns:a16="http://schemas.microsoft.com/office/drawing/2014/main" val="3801006370"/>
                    </a:ext>
                  </a:extLst>
                </a:gridCol>
                <a:gridCol w="949522">
                  <a:extLst>
                    <a:ext uri="{9D8B030D-6E8A-4147-A177-3AD203B41FA5}">
                      <a16:colId xmlns:a16="http://schemas.microsoft.com/office/drawing/2014/main" val="4025396820"/>
                    </a:ext>
                  </a:extLst>
                </a:gridCol>
                <a:gridCol w="647909">
                  <a:extLst>
                    <a:ext uri="{9D8B030D-6E8A-4147-A177-3AD203B41FA5}">
                      <a16:colId xmlns:a16="http://schemas.microsoft.com/office/drawing/2014/main" val="3358853044"/>
                    </a:ext>
                  </a:extLst>
                </a:gridCol>
              </a:tblGrid>
              <a:tr h="240910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5 &lt;= BMI &lt; 24.9 (n=20)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.0 &lt;= BMI &lt; 29.9 (n=21)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0 &lt;= BMI &lt; 34.9 (n=7)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(n=48)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5155646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ction # 1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666086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2933220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fiducial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1971046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5832111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06008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0513173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9028300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ction # 2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4594195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 (9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(95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 (93.8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2239565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fiducial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2.1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3087699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4.8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4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6725573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0773389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5100772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2844498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ction # 3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4564454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 (8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(95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 (91.7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7830305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fiducial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1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4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4507367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4.8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4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8797802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6938461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57387451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91944858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ction # 4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8926300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 (8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 (9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(85.7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 (87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0988572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fiducial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1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4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(8.5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1603684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4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33985440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3511706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9943217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524072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ction # 5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0859820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 (8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 (89.5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(85.7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 (87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33575710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fiducial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1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5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4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(8.7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8207447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5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4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9371978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14519839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7349933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5659687"/>
                  </a:ext>
                </a:extLst>
              </a:tr>
              <a:tr h="240910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undetected fiducials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2684690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 (7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 (90.5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(85.7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 (83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7927733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4.8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4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4329195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1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4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6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163169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2.1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2484678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5065791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4.8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4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6536983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0931266"/>
                  </a:ext>
                </a:extLst>
              </a:tr>
              <a:tr h="240910"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undetected fiducials per group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4280115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 (7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 (90.5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(85.7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 (83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2038274"/>
                  </a:ext>
                </a:extLst>
              </a:tr>
              <a:tr h="240910"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 least 1 undetected fiducial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 (2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9.5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4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 (16.7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0231176"/>
                  </a:ext>
                </a:extLst>
              </a:tr>
              <a:tr h="1204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98272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664475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>
            <a:extLst>
              <a:ext uri="{FF2B5EF4-FFF2-40B4-BE49-F238E27FC236}">
                <a16:creationId xmlns:a16="http://schemas.microsoft.com/office/drawing/2014/main" id="{4254897F-C09A-492D-86D6-2B0619941C2E}"/>
              </a:ext>
            </a:extLst>
          </p:cNvPr>
          <p:cNvSpPr/>
          <p:nvPr/>
        </p:nvSpPr>
        <p:spPr>
          <a:xfrm>
            <a:off x="3048000" y="857238"/>
            <a:ext cx="6096000" cy="514352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Implant Geometry and Detection Rates of Prostate Fiducial Markers after Trans-Rectal-Ultrasound-Guided Perineal Implantation for Image-Guided 6D-Tracking Robotic Stereotactic Body Radiotherapy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 err="1">
                <a:latin typeface="Calibri" panose="020F0502020204030204" pitchFamily="34" charset="0"/>
                <a:ea typeface="Times New Roman" panose="02020603050405020304" pitchFamily="18" charset="0"/>
              </a:rPr>
              <a:t>Strahlentherapie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 und </a:t>
            </a:r>
            <a:r>
              <a:rPr lang="en-US" sz="1100" dirty="0" err="1">
                <a:latin typeface="Calibri" panose="020F0502020204030204" pitchFamily="34" charset="0"/>
                <a:ea typeface="Times New Roman" panose="02020603050405020304" pitchFamily="18" charset="0"/>
              </a:rPr>
              <a:t>Onkologie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Arne Gruen, 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Katharina Heil</a:t>
            </a: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, 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Daniel Zips, Goda Kalinauskaite</a:t>
            </a: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, Dirk Boehmer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b="1" dirty="0">
                <a:latin typeface="Calibri" panose="020F0502020204030204" pitchFamily="34" charset="0"/>
                <a:ea typeface="Times New Roman" panose="02020603050405020304" pitchFamily="18" charset="0"/>
              </a:rPr>
              <a:t>Corresponding Author: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Arne Gruen, MD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Department for Radiation Oncology,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</a:rPr>
              <a:t>Charité </a:t>
            </a:r>
            <a:r>
              <a:rPr lang="en-US" sz="1100" i="1" dirty="0">
                <a:latin typeface="Calibri" panose="020F0502020204030204" pitchFamily="34" charset="0"/>
                <a:ea typeface="Calibri" panose="020F0502020204030204" pitchFamily="34" charset="0"/>
              </a:rPr>
              <a:t>–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</a:rPr>
              <a:t>Universitaetsmedizin Berlin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</a:rPr>
              <a:t>Corporate member of Freie Universitaet Berlin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Calibri" panose="020F0502020204030204" pitchFamily="34" charset="0"/>
              </a:rPr>
              <a:t>Humboldt-Universitaet zu Berlin and Berlin Institute of Health</a:t>
            </a: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Campus Virchow-Klinikum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Augustenburger Platz 1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13353 Berlin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Germany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Tel: 0049-30-450-627219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Fax: 0049-30-450-7527152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Email: </a:t>
            </a:r>
            <a:r>
              <a:rPr lang="en-GB" sz="1100" b="1" dirty="0">
                <a:latin typeface="Calibri" panose="020F0502020204030204" pitchFamily="34" charset="0"/>
                <a:ea typeface="Times New Roman" panose="02020603050405020304" pitchFamily="18" charset="0"/>
              </a:rPr>
              <a:t>arne.gruen@charite.de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ORCID: 0000-0002-3868-2719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73050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0</Words>
  <Application>Microsoft Office PowerPoint</Application>
  <PresentationFormat>Breitbild</PresentationFormat>
  <Paragraphs>308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rün, Arne</dc:creator>
  <cp:lastModifiedBy>A</cp:lastModifiedBy>
  <cp:revision>11</cp:revision>
  <dcterms:created xsi:type="dcterms:W3CDTF">2024-08-03T06:43:40Z</dcterms:created>
  <dcterms:modified xsi:type="dcterms:W3CDTF">2025-01-05T13:58:13Z</dcterms:modified>
</cp:coreProperties>
</file>